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256" r:id="rId2"/>
    <p:sldId id="260" r:id="rId3"/>
    <p:sldId id="269" r:id="rId4"/>
    <p:sldId id="257" r:id="rId5"/>
    <p:sldId id="268" r:id="rId6"/>
    <p:sldId id="270" r:id="rId7"/>
    <p:sldId id="258" r:id="rId8"/>
    <p:sldId id="259" r:id="rId9"/>
    <p:sldId id="265" r:id="rId10"/>
    <p:sldId id="266" r:id="rId11"/>
    <p:sldId id="271" r:id="rId1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esley Hoyles" initials="" lastIdx="2" clrIdx="0"/>
  <p:cmAuthor id="1" name="Lesley Hoyles" initials="LH" lastIdx="2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00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573" autoAdjust="0"/>
    <p:restoredTop sz="95934" autoAdjust="0"/>
  </p:normalViewPr>
  <p:slideViewPr>
    <p:cSldViewPr snapToGrid="0" snapToObjects="1">
      <p:cViewPr>
        <p:scale>
          <a:sx n="150" d="100"/>
          <a:sy n="150" d="100"/>
        </p:scale>
        <p:origin x="-3208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notesMaster" Target="notesMasters/notesMaster1.xml"/><Relationship Id="rId14" Type="http://schemas.openxmlformats.org/officeDocument/2006/relationships/printerSettings" Target="printerSettings/printerSettings1.bin"/><Relationship Id="rId15" Type="http://schemas.openxmlformats.org/officeDocument/2006/relationships/commentAuthors" Target="commentAuthors.xml"/><Relationship Id="rId16" Type="http://schemas.openxmlformats.org/officeDocument/2006/relationships/presProps" Target="presProps.xml"/><Relationship Id="rId17" Type="http://schemas.openxmlformats.org/officeDocument/2006/relationships/viewProps" Target="viewProps.xml"/><Relationship Id="rId18" Type="http://schemas.openxmlformats.org/officeDocument/2006/relationships/theme" Target="theme/theme1.xml"/><Relationship Id="rId1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51C623-EABD-4919-86CC-0EDCB4D8A709}" type="datetimeFigureOut">
              <a:rPr lang="en-GB" smtClean="0"/>
              <a:t>14/09/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B50F37-8858-487D-BEA1-F50F3A664A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6110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B50F37-8858-487D-BEA1-F50F3A664A7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340679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B50F37-8858-487D-BEA1-F50F3A664A7E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20833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B50F37-8858-487D-BEA1-F50F3A664A7E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898866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B50F37-8858-487D-BEA1-F50F3A664A7E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239334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B50F37-8858-487D-BEA1-F50F3A664A7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035060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B50F37-8858-487D-BEA1-F50F3A664A7E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330856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B50F37-8858-487D-BEA1-F50F3A664A7E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371843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B50F37-8858-487D-BEA1-F50F3A664A7E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139084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B50F37-8858-487D-BEA1-F50F3A664A7E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32549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055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823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98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6749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77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491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75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930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22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635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264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A779C5-E246-BC49-8D20-E408480624CA}" type="datetimeFigureOut">
              <a:rPr lang="en-US" smtClean="0"/>
              <a:t>14/0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4796ED-03D0-3E45-98CE-F71BF4003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264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50560" y="371505"/>
            <a:ext cx="2229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igure 1</a:t>
            </a:r>
            <a:endParaRPr lang="en-US" sz="1400" dirty="0"/>
          </a:p>
        </p:txBody>
      </p:sp>
      <p:pic>
        <p:nvPicPr>
          <p:cNvPr id="9" name="Picture 8" descr="Figure_1_Yuhao_paper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012" y="1441704"/>
            <a:ext cx="6665976" cy="62605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58180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0560" y="371505"/>
            <a:ext cx="2229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igure 6</a:t>
            </a:r>
          </a:p>
        </p:txBody>
      </p:sp>
      <p:pic>
        <p:nvPicPr>
          <p:cNvPr id="3" name="Picture 2" descr="Figure_6_070919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128" y="640080"/>
            <a:ext cx="5571744" cy="7863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29193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Supplementary_Figure_5_070919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8750" y="0"/>
            <a:ext cx="5280501" cy="9144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672CDED3-0E4F-BA4E-A6D7-852E0FB415B3}"/>
              </a:ext>
            </a:extLst>
          </p:cNvPr>
          <p:cNvSpPr txBox="1"/>
          <p:nvPr/>
        </p:nvSpPr>
        <p:spPr>
          <a:xfrm>
            <a:off x="3812910" y="346105"/>
            <a:ext cx="2540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</a:rPr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11676305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0560" y="371505"/>
            <a:ext cx="13759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ementary Figure 1</a:t>
            </a:r>
          </a:p>
        </p:txBody>
      </p:sp>
      <p:pic>
        <p:nvPicPr>
          <p:cNvPr id="4" name="Picture 3" descr="Supplementary_Figure_1_070919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6550" y="0"/>
            <a:ext cx="5231450" cy="914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1884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5448BEB4-0909-764B-825F-E09436F9BAFA}"/>
              </a:ext>
            </a:extLst>
          </p:cNvPr>
          <p:cNvSpPr txBox="1"/>
          <p:nvPr/>
        </p:nvSpPr>
        <p:spPr>
          <a:xfrm>
            <a:off x="250560" y="371505"/>
            <a:ext cx="27275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ementary Figure 2</a:t>
            </a:r>
          </a:p>
        </p:txBody>
      </p:sp>
      <p:pic>
        <p:nvPicPr>
          <p:cNvPr id="2" name="Picture 1" descr="Supplementary_Figure_2_070919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49979"/>
            <a:ext cx="6858000" cy="64440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63553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0560" y="371505"/>
            <a:ext cx="27275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igure 2</a:t>
            </a:r>
          </a:p>
        </p:txBody>
      </p:sp>
      <p:pic>
        <p:nvPicPr>
          <p:cNvPr id="5" name="Picture 4" descr="Figure2_200819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000" y="821436"/>
            <a:ext cx="5400000" cy="81881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27586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pplementary_Figure_3_070919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09" y="72000"/>
            <a:ext cx="5235382" cy="900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314559" y="142905"/>
            <a:ext cx="2458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17754344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E74C8A0A-431D-A140-A181-B1AA41770021}"/>
              </a:ext>
            </a:extLst>
          </p:cNvPr>
          <p:cNvSpPr txBox="1"/>
          <p:nvPr/>
        </p:nvSpPr>
        <p:spPr>
          <a:xfrm>
            <a:off x="250560" y="371505"/>
            <a:ext cx="2229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igure 3</a:t>
            </a:r>
          </a:p>
        </p:txBody>
      </p:sp>
      <p:pic>
        <p:nvPicPr>
          <p:cNvPr id="2" name="Picture 1" descr="Figure_3_070919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30841"/>
            <a:ext cx="6858000" cy="62823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50029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0560" y="371505"/>
            <a:ext cx="2229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igure 4</a:t>
            </a:r>
          </a:p>
        </p:txBody>
      </p:sp>
      <p:pic>
        <p:nvPicPr>
          <p:cNvPr id="2" name="Picture 1" descr="Figure_4_070919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9304" y="2674620"/>
            <a:ext cx="4279392" cy="3794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82376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50560" y="371505"/>
            <a:ext cx="2229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igure 5</a:t>
            </a:r>
          </a:p>
        </p:txBody>
      </p:sp>
      <p:pic>
        <p:nvPicPr>
          <p:cNvPr id="3" name="Picture 2" descr="Figure_4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01" y="778761"/>
            <a:ext cx="6803999" cy="79173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1914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0560" y="371505"/>
            <a:ext cx="2540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</a:rPr>
              <a:t>Supplementary Figure 4</a:t>
            </a:r>
          </a:p>
        </p:txBody>
      </p:sp>
      <p:pic>
        <p:nvPicPr>
          <p:cNvPr id="2" name="Picture 1" descr="Figure6A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10315"/>
            <a:ext cx="6858000" cy="4123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652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72</TotalTime>
  <Words>36</Words>
  <Application>Microsoft Macintosh PowerPoint</Application>
  <PresentationFormat>On-screen Show (4:3)</PresentationFormat>
  <Paragraphs>20</Paragraphs>
  <Slides>11</Slides>
  <Notes>9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sley Hoyles</dc:creator>
  <cp:lastModifiedBy>Lesley Hoyles</cp:lastModifiedBy>
  <cp:revision>174</cp:revision>
  <dcterms:created xsi:type="dcterms:W3CDTF">2018-05-07T17:07:58Z</dcterms:created>
  <dcterms:modified xsi:type="dcterms:W3CDTF">2019-09-14T11:51:41Z</dcterms:modified>
</cp:coreProperties>
</file>